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38F53-DFA7-4FFA-A99C-A21EA11672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C0C87-55E9-4D40-BCCC-A926D41A5E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20E49-3B49-4A4D-9C23-6E1B752827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6D6EE-E55F-4E81-97DD-F659DA13F6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CE22A-0BCE-46F8-8AB3-8F316BF9DE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194F2-F17F-4FD6-9299-F8FE1AFCC3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6CEF1-D880-45C3-A337-70E771BE82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21EAF-A835-4D0B-9C85-E20575268F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FD5E0-0A60-416A-B29F-68263C2B3B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75015-5368-4C84-BCBA-6DFF41876D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9FB0E-0466-4C97-9E6F-A074F06B73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B20AF-7075-463D-8041-0CC50C1F26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B4B78A-5536-4281-9ACA-551BD10AD80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7"/>
          <p:cNvSpPr/>
          <p:nvPr/>
        </p:nvSpPr>
        <p:spPr>
          <a:xfrm>
            <a:off x="-1405080" y="-833400"/>
            <a:ext cx="11954160" cy="852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5"/>
          <p:cNvSpPr/>
          <p:nvPr/>
        </p:nvSpPr>
        <p:spPr>
          <a:xfrm>
            <a:off x="1076400" y="1411200"/>
            <a:ext cx="6991200" cy="498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8" descr=""/>
          <p:cNvPicPr/>
          <p:nvPr/>
        </p:nvPicPr>
        <p:blipFill>
          <a:blip r:embed="rId1"/>
          <a:stretch/>
        </p:blipFill>
        <p:spPr>
          <a:xfrm>
            <a:off x="620640" y="1093680"/>
            <a:ext cx="7921800" cy="5648400"/>
          </a:xfrm>
          <a:prstGeom prst="rect">
            <a:avLst/>
          </a:prstGeom>
          <a:ln w="0">
            <a:noFill/>
          </a:ln>
        </p:spPr>
      </p:pic>
      <p:sp>
        <p:nvSpPr>
          <p:cNvPr id="44" name="Text Box 10"/>
          <p:cNvSpPr/>
          <p:nvPr/>
        </p:nvSpPr>
        <p:spPr>
          <a:xfrm>
            <a:off x="4334040" y="44370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2"/>
          <p:cNvSpPr/>
          <p:nvPr/>
        </p:nvSpPr>
        <p:spPr>
          <a:xfrm>
            <a:off x="6667920" y="25671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3"/>
          <p:cNvSpPr/>
          <p:nvPr/>
        </p:nvSpPr>
        <p:spPr>
          <a:xfrm>
            <a:off x="3710160" y="1268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6"/>
          <p:cNvSpPr/>
          <p:nvPr/>
        </p:nvSpPr>
        <p:spPr>
          <a:xfrm>
            <a:off x="5078880" y="47973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7"/>
          <p:cNvSpPr/>
          <p:nvPr/>
        </p:nvSpPr>
        <p:spPr>
          <a:xfrm>
            <a:off x="4142160" y="50846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8"/>
          <p:cNvSpPr/>
          <p:nvPr/>
        </p:nvSpPr>
        <p:spPr>
          <a:xfrm>
            <a:off x="925920" y="59245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9"/>
          <p:cNvSpPr/>
          <p:nvPr/>
        </p:nvSpPr>
        <p:spPr>
          <a:xfrm>
            <a:off x="7791840" y="33814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0"/>
          <p:cNvSpPr/>
          <p:nvPr/>
        </p:nvSpPr>
        <p:spPr>
          <a:xfrm>
            <a:off x="678960" y="2076480"/>
            <a:ext cx="26010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Malagueñ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Murciano-Granadi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Palme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Blanca de Rasquer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Mallorqui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Bermey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ffffff"/>
              </a:buClr>
              <a:buFont typeface="Arial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ffffff"/>
                </a:solidFill>
                <a:latin typeface="Arial"/>
              </a:rPr>
              <a:t>Flori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2"/>
          <p:cNvSpPr/>
          <p:nvPr/>
        </p:nvSpPr>
        <p:spPr>
          <a:xfrm>
            <a:off x="620640" y="98280"/>
            <a:ext cx="79120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eographic distribution of the Spanish goat breeds under analysis. The map of Spain https://commons.wikimedia.org/wiki/File:Blank_Spain_Map_(Provinces).svg) is licensed under the Creative Commons Attribution-Share Alike 3.0 Unported license. The license terms can be found on the following link: https://creativecommons.org/licenses/by-sa/3.0/deed.e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18T16:43:44Z</dcterms:created>
  <dc:creator>Universitat Autònoma de Barcelona</dc:creator>
  <dc:description/>
  <dc:language>en-US</dc:language>
  <cp:lastModifiedBy>Universitat Autònoma de Barcelona</cp:lastModifiedBy>
  <dcterms:modified xsi:type="dcterms:W3CDTF">2016-05-12T09:44:56Z</dcterms:modified>
  <cp:revision>9</cp:revision>
  <dc:subject/>
  <dc:title>Diapositiva 1</dc:title>
</cp:coreProperties>
</file>